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  <p:sldId id="260" r:id="rId3"/>
    <p:sldId id="261" r:id="rId4"/>
    <p:sldId id="262" r:id="rId5"/>
    <p:sldId id="263" r:id="rId6"/>
  </p:sldIdLst>
  <p:sldSz cx="1069181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olinska@o365.umk.pl" initials="g" lastIdx="1" clrIdx="0">
    <p:extLst>
      <p:ext uri="{19B8F6BF-5375-455C-9EA6-DF929625EA0E}">
        <p15:presenceInfo xmlns:p15="http://schemas.microsoft.com/office/powerpoint/2012/main" userId="S-1-5-21-1643980899-998416530-2674123739-100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117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1886" y="1237197"/>
            <a:ext cx="9088041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36477" y="3970580"/>
            <a:ext cx="8018860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27500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03860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51329" y="402483"/>
            <a:ext cx="2305422" cy="6406475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5063" y="402483"/>
            <a:ext cx="6782619" cy="6406475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47067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36612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494" y="1884671"/>
            <a:ext cx="9221689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9494" y="5059035"/>
            <a:ext cx="9221689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1636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5062" y="2012414"/>
            <a:ext cx="4544021" cy="4796544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12730" y="2012414"/>
            <a:ext cx="4544021" cy="4796544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95712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402484"/>
            <a:ext cx="9221689" cy="1461188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456" y="1853171"/>
            <a:ext cx="4523137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6456" y="2761381"/>
            <a:ext cx="4523137" cy="4061576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12731" y="1853171"/>
            <a:ext cx="4545413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12731" y="2761381"/>
            <a:ext cx="4545413" cy="4061576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17056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4634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30687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503978"/>
            <a:ext cx="344838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45413" y="1088455"/>
            <a:ext cx="5412730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2267902"/>
            <a:ext cx="344838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1849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455" y="503978"/>
            <a:ext cx="3448388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45413" y="1088455"/>
            <a:ext cx="5412730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6455" y="2267902"/>
            <a:ext cx="3448388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57019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5062" y="402484"/>
            <a:ext cx="9221689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5062" y="2012414"/>
            <a:ext cx="9221689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5062" y="7006700"/>
            <a:ext cx="24056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A07C0-E395-49D2-BEDF-DB5200196218}" type="datetimeFigureOut">
              <a:rPr lang="pl-PL" smtClean="0"/>
              <a:t>17.07.2023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41663" y="7006700"/>
            <a:ext cx="360848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51093" y="7006700"/>
            <a:ext cx="240565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8ECC1-B58A-4F0D-86D3-BEC9EA6330D7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51900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mwypij@umk.pl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10" Type="http://schemas.openxmlformats.org/officeDocument/2006/relationships/image" Target="../media/image19.jpeg"/><Relationship Id="rId4" Type="http://schemas.openxmlformats.org/officeDocument/2006/relationships/image" Target="../media/image13.jpeg"/><Relationship Id="rId9" Type="http://schemas.openxmlformats.org/officeDocument/2006/relationships/image" Target="../media/image1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10" Type="http://schemas.openxmlformats.org/officeDocument/2006/relationships/image" Target="../media/image28.jpeg"/><Relationship Id="rId4" Type="http://schemas.openxmlformats.org/officeDocument/2006/relationships/image" Target="../media/image22.jpeg"/><Relationship Id="rId9" Type="http://schemas.openxmlformats.org/officeDocument/2006/relationships/image" Target="../media/image2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rostokąt 1">
            <a:extLst>
              <a:ext uri="{FF2B5EF4-FFF2-40B4-BE49-F238E27FC236}">
                <a16:creationId xmlns:a16="http://schemas.microsoft.com/office/drawing/2014/main" id="{5F3AC939-AA8A-4AD4-9B31-437914234D26}"/>
              </a:ext>
            </a:extLst>
          </p:cNvPr>
          <p:cNvSpPr/>
          <p:nvPr/>
        </p:nvSpPr>
        <p:spPr>
          <a:xfrm>
            <a:off x="496111" y="308788"/>
            <a:ext cx="9795753" cy="34722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</a:pPr>
            <a:r>
              <a:rPr lang="pl-PL" sz="16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pl-PL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pl-PL" sz="16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erial</a:t>
            </a:r>
            <a:endParaRPr lang="pl-PL" sz="16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endParaRPr lang="pl-PL" sz="16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ullulan-based films impregnated with silver nanoparticles from  </a:t>
            </a:r>
            <a:r>
              <a:rPr lang="pl-PL" sz="1600" b="1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sarium</a:t>
            </a:r>
            <a:r>
              <a:rPr lang="pl-PL" sz="16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b="1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ulmorum</a:t>
            </a:r>
            <a:r>
              <a:rPr lang="pl-PL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b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pl-PL" sz="16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JTW1 </a:t>
            </a:r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potential applications in food industry and medicine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gdalena Wypij</a:t>
            </a: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hendra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ai</a:t>
            </a: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dija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as Zemljič</a:t>
            </a: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tej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čič</a:t>
            </a:r>
            <a:r>
              <a:rPr lang="pl-PL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lvo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ribernik</a:t>
            </a: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atrycja Golińska</a:t>
            </a: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Microbiology, Nicolaus Copernicus University in Torun, Torun, Poland; 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Nanobiotechnology Laboratory, Department of Biotechnology, SGB Amravati University, Amravati, India 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GB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aculty of Mechanical Engineering, University of Maribor, Maribor, Slovenia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pt-BR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pt-BR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</a:t>
            </a:r>
            <a:r>
              <a:rPr lang="pt-BR" sz="1600" u="sng" dirty="0">
                <a:solidFill>
                  <a:srgbClr val="0000FF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mwypij@umk.pl</a:t>
            </a:r>
            <a:r>
              <a:rPr lang="pt-BR" sz="1600" u="sng" dirty="0">
                <a:solidFill>
                  <a:srgbClr val="0000FF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golinska@umk.pl</a:t>
            </a:r>
            <a:endParaRPr lang="pl-PL" sz="16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4422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Obraz 2">
            <a:extLst>
              <a:ext uri="{FF2B5EF4-FFF2-40B4-BE49-F238E27FC236}">
                <a16:creationId xmlns:a16="http://schemas.microsoft.com/office/drawing/2014/main" id="{C150EAD7-6113-46CA-9F20-0205077C2BD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35" t="5600" r="5682" b="50000"/>
          <a:stretch/>
        </p:blipFill>
        <p:spPr>
          <a:xfrm>
            <a:off x="1838529" y="239957"/>
            <a:ext cx="7052552" cy="5248421"/>
          </a:xfrm>
          <a:prstGeom prst="rect">
            <a:avLst/>
          </a:prstGeom>
        </p:spPr>
      </p:pic>
      <p:sp>
        <p:nvSpPr>
          <p:cNvPr id="4" name="pole tekstowe 3">
            <a:extLst>
              <a:ext uri="{FF2B5EF4-FFF2-40B4-BE49-F238E27FC236}">
                <a16:creationId xmlns:a16="http://schemas.microsoft.com/office/drawing/2014/main" id="{4D01151C-A04C-408A-A3A2-99F2D5F59842}"/>
              </a:ext>
            </a:extLst>
          </p:cNvPr>
          <p:cNvSpPr txBox="1"/>
          <p:nvPr/>
        </p:nvSpPr>
        <p:spPr>
          <a:xfrm>
            <a:off x="5036273" y="4556490"/>
            <a:ext cx="1216090" cy="2663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13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pl-PL" sz="11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</a:t>
            </a:r>
            <a:r>
              <a:rPr lang="pl-PL" sz="113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pl-PL" sz="11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]</a:t>
            </a:r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id="{5EF905A8-0093-45E4-A4C2-1EE8D2BCF1DE}"/>
              </a:ext>
            </a:extLst>
          </p:cNvPr>
          <p:cNvSpPr txBox="1"/>
          <p:nvPr/>
        </p:nvSpPr>
        <p:spPr>
          <a:xfrm flipH="1">
            <a:off x="2278548" y="5528757"/>
            <a:ext cx="67315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. Histogram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NPs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sized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pl-PL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sarium</a:t>
            </a:r>
            <a:r>
              <a:rPr lang="pl-PL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morun</a:t>
            </a:r>
            <a:r>
              <a:rPr lang="pl-PL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TW1</a:t>
            </a:r>
          </a:p>
        </p:txBody>
      </p:sp>
    </p:spTree>
    <p:extLst>
      <p:ext uri="{BB962C8B-B14F-4D97-AF65-F5344CB8AC3E}">
        <p14:creationId xmlns:p14="http://schemas.microsoft.com/office/powerpoint/2010/main" val="30476131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ela 8">
            <a:extLst>
              <a:ext uri="{FF2B5EF4-FFF2-40B4-BE49-F238E27FC236}">
                <a16:creationId xmlns:a16="http://schemas.microsoft.com/office/drawing/2014/main" id="{8F342626-894D-49A5-8F4B-A2D0CDACB8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7177891"/>
              </p:ext>
            </p:extLst>
          </p:nvPr>
        </p:nvGraphicFramePr>
        <p:xfrm>
          <a:off x="1303505" y="1296738"/>
          <a:ext cx="2680781" cy="54737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80781">
                  <a:extLst>
                    <a:ext uri="{9D8B030D-6E8A-4147-A177-3AD203B41FA5}">
                      <a16:colId xmlns:a16="http://schemas.microsoft.com/office/drawing/2014/main" val="3789433340"/>
                    </a:ext>
                  </a:extLst>
                </a:gridCol>
              </a:tblGrid>
              <a:tr h="1526065">
                <a:tc>
                  <a:txBody>
                    <a:bodyPr/>
                    <a:lstStyle/>
                    <a:p>
                      <a:r>
                        <a:rPr lang="pl-PL" sz="1600" b="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scherichia coli </a:t>
                      </a:r>
                    </a:p>
                    <a:p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scherichia coli</a:t>
                      </a:r>
                    </a:p>
                    <a:p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 25922</a:t>
                      </a:r>
                      <a:endParaRPr lang="pl-PL" sz="1600" b="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6712336"/>
                  </a:ext>
                </a:extLst>
              </a:tr>
              <a:tr h="2756089">
                <a:tc>
                  <a:txBody>
                    <a:bodyPr/>
                    <a:lstStyle/>
                    <a:p>
                      <a:endParaRPr lang="pl-PL" sz="1600" b="0" i="1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endParaRPr lang="pl-PL" sz="1600" b="0" i="1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endParaRPr lang="pl-PL" sz="1600" b="0" i="1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scherichia coli</a:t>
                      </a:r>
                      <a:endParaRPr lang="pl-PL" sz="1600" b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 8739</a:t>
                      </a: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1111575"/>
                  </a:ext>
                </a:extLst>
              </a:tr>
              <a:tr h="1191559">
                <a:tc>
                  <a:txBody>
                    <a:bodyPr/>
                    <a:lstStyle/>
                    <a:p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lebsiella</a:t>
                      </a:r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neumoniae</a:t>
                      </a:r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endParaRPr lang="pl-PL" sz="1600" b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 700603</a:t>
                      </a: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6538287"/>
                  </a:ext>
                </a:extLst>
              </a:tr>
            </a:tbl>
          </a:graphicData>
        </a:graphic>
      </p:graphicFrame>
      <p:grpSp>
        <p:nvGrpSpPr>
          <p:cNvPr id="5" name="Grupa 4">
            <a:extLst>
              <a:ext uri="{FF2B5EF4-FFF2-40B4-BE49-F238E27FC236}">
                <a16:creationId xmlns:a16="http://schemas.microsoft.com/office/drawing/2014/main" id="{7BCF5149-35EF-422B-86C6-84D96D707849}"/>
              </a:ext>
            </a:extLst>
          </p:cNvPr>
          <p:cNvGrpSpPr/>
          <p:nvPr/>
        </p:nvGrpSpPr>
        <p:grpSpPr>
          <a:xfrm>
            <a:off x="3984279" y="637514"/>
            <a:ext cx="6369484" cy="6352550"/>
            <a:chOff x="3984279" y="637514"/>
            <a:chExt cx="6369484" cy="6352550"/>
          </a:xfrm>
        </p:grpSpPr>
        <p:pic>
          <p:nvPicPr>
            <p:cNvPr id="102" name="Obraz 101">
              <a:extLst>
                <a:ext uri="{FF2B5EF4-FFF2-40B4-BE49-F238E27FC236}">
                  <a16:creationId xmlns:a16="http://schemas.microsoft.com/office/drawing/2014/main" id="{2B77150F-F6FE-40E4-ABEC-74CF181D7CA0}"/>
                </a:ext>
              </a:extLst>
            </p:cNvPr>
            <p:cNvPicPr/>
            <p:nvPr/>
          </p:nvPicPr>
          <p:blipFill rotWithShape="1">
            <a:blip r:embed="rId2"/>
            <a:srcRect l="43670" t="27938" r="36471" b="35795"/>
            <a:stretch/>
          </p:blipFill>
          <p:spPr bwMode="auto">
            <a:xfrm rot="10800000">
              <a:off x="3984279" y="655661"/>
              <a:ext cx="2091863" cy="208129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4" name="Obraz 103" descr="C:\folie_3% pullulan +0,75% glicerol\listopad zdjęcia oddziaływania\IMG_20221020_102858.jpg">
              <a:extLst>
                <a:ext uri="{FF2B5EF4-FFF2-40B4-BE49-F238E27FC236}">
                  <a16:creationId xmlns:a16="http://schemas.microsoft.com/office/drawing/2014/main" id="{26057992-D3D4-4BF0-BF4A-9DAB3DB475E8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001" r="6144" b="10696"/>
            <a:stretch/>
          </p:blipFill>
          <p:spPr bwMode="auto">
            <a:xfrm>
              <a:off x="6076149" y="655800"/>
              <a:ext cx="2091862" cy="2084546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5" name="Obraz 104" descr="C:\folie_3% pullulan +0,75% glicerol\metoda patyczkiem\IMG_20220527_122905.jpg">
              <a:extLst>
                <a:ext uri="{FF2B5EF4-FFF2-40B4-BE49-F238E27FC236}">
                  <a16:creationId xmlns:a16="http://schemas.microsoft.com/office/drawing/2014/main" id="{4FA8BF61-B658-4781-88DB-A4CB2CA3EB8E}"/>
                </a:ext>
              </a:extLst>
            </p:cNvPr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547" b="7948"/>
            <a:stretch/>
          </p:blipFill>
          <p:spPr bwMode="auto">
            <a:xfrm>
              <a:off x="8168012" y="637514"/>
              <a:ext cx="2185744" cy="21118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6" name="Obraz 105" descr="C:\folie_3% pullulan +0,75% glicerol\listopad zdjęcia oddziaływania\IMG_20221020_102640.jpg">
              <a:extLst>
                <a:ext uri="{FF2B5EF4-FFF2-40B4-BE49-F238E27FC236}">
                  <a16:creationId xmlns:a16="http://schemas.microsoft.com/office/drawing/2014/main" id="{D079E035-0130-46FD-AADA-6FC45360F263}"/>
                </a:ext>
              </a:extLst>
            </p:cNvPr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699" r="7143" b="5730"/>
            <a:stretch/>
          </p:blipFill>
          <p:spPr bwMode="auto">
            <a:xfrm>
              <a:off x="3984295" y="2736958"/>
              <a:ext cx="2091862" cy="213537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7" name="Obraz 106" descr="C:\folie_3% pullulan +0,75% glicerol\listopad zdjęcia oddziaływania\IMG_20221020_102757.jpg">
              <a:extLst>
                <a:ext uri="{FF2B5EF4-FFF2-40B4-BE49-F238E27FC236}">
                  <a16:creationId xmlns:a16="http://schemas.microsoft.com/office/drawing/2014/main" id="{508E97B8-8366-44E1-A6C8-2BB6DAEE277A}"/>
                </a:ext>
              </a:extLst>
            </p:cNvPr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325" r="8008" b="11163"/>
            <a:stretch/>
          </p:blipFill>
          <p:spPr bwMode="auto">
            <a:xfrm>
              <a:off x="6019149" y="2746103"/>
              <a:ext cx="2185744" cy="211118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8" name="Obraz 107" descr="C:\Users\AcerAspire\Desktop\IS 2XMIC.png">
              <a:extLst>
                <a:ext uri="{FF2B5EF4-FFF2-40B4-BE49-F238E27FC236}">
                  <a16:creationId xmlns:a16="http://schemas.microsoft.com/office/drawing/2014/main" id="{0F9D0540-5A72-4923-B716-2B38DB8DF361}"/>
                </a:ext>
              </a:extLst>
            </p:cNvPr>
            <p:cNvPicPr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" t="15894" b="13907"/>
            <a:stretch/>
          </p:blipFill>
          <p:spPr bwMode="auto">
            <a:xfrm>
              <a:off x="8168019" y="2742853"/>
              <a:ext cx="2185744" cy="211118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9" name="Obraz 108" descr="C:\folie_3% pullulan +0,75% glicerol\metoda patyczkiem\Nowy folder\IMG_20220719_132722.jpg">
              <a:extLst>
                <a:ext uri="{FF2B5EF4-FFF2-40B4-BE49-F238E27FC236}">
                  <a16:creationId xmlns:a16="http://schemas.microsoft.com/office/drawing/2014/main" id="{9A138E14-B63B-4F5D-B3B4-27E31232748D}"/>
                </a:ext>
              </a:extLst>
            </p:cNvPr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71" t="27136" r="13203" b="13910"/>
            <a:stretch/>
          </p:blipFill>
          <p:spPr bwMode="auto">
            <a:xfrm>
              <a:off x="3984286" y="4872331"/>
              <a:ext cx="2034857" cy="2117733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10" name="Obraz 109" descr="C:\folie_3% pullulan +0,75% glicerol\listopad zdjęcia oddziaływania\IMG_20221020_102616.jpg">
              <a:extLst>
                <a:ext uri="{FF2B5EF4-FFF2-40B4-BE49-F238E27FC236}">
                  <a16:creationId xmlns:a16="http://schemas.microsoft.com/office/drawing/2014/main" id="{D6FCCE5E-FF72-4D6A-8251-97A1A71487B3}"/>
                </a:ext>
              </a:extLst>
            </p:cNvPr>
            <p:cNvPicPr/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009" r="11905" b="9324"/>
            <a:stretch/>
          </p:blipFill>
          <p:spPr bwMode="auto">
            <a:xfrm>
              <a:off x="6019149" y="4854693"/>
              <a:ext cx="2148856" cy="213537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11" name="Obraz 110" descr="C:\folie_3% pullulan +0,75% glicerol\listopad zdjęcia oddziaływania\IMG_20221020_102825.jpg">
              <a:extLst>
                <a:ext uri="{FF2B5EF4-FFF2-40B4-BE49-F238E27FC236}">
                  <a16:creationId xmlns:a16="http://schemas.microsoft.com/office/drawing/2014/main" id="{1388F58A-0902-431D-A145-FA9189B9CE20}"/>
                </a:ext>
              </a:extLst>
            </p:cNvPr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11" t="25723" r="11111" b="15815"/>
            <a:stretch/>
          </p:blipFill>
          <p:spPr bwMode="auto">
            <a:xfrm>
              <a:off x="8168012" y="4854693"/>
              <a:ext cx="2185744" cy="213537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114" name="pole tekstowe 113">
            <a:extLst>
              <a:ext uri="{FF2B5EF4-FFF2-40B4-BE49-F238E27FC236}">
                <a16:creationId xmlns:a16="http://schemas.microsoft.com/office/drawing/2014/main" id="{27D2F0B4-1B54-41CB-8EAE-17992728E2E5}"/>
              </a:ext>
            </a:extLst>
          </p:cNvPr>
          <p:cNvSpPr txBox="1"/>
          <p:nvPr/>
        </p:nvSpPr>
        <p:spPr>
          <a:xfrm flipH="1">
            <a:off x="5948453" y="-17637"/>
            <a:ext cx="2493047" cy="347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/>
              <a:t>Concentration</a:t>
            </a:r>
            <a:r>
              <a:rPr lang="pl-PL" dirty="0"/>
              <a:t> of </a:t>
            </a:r>
            <a:r>
              <a:rPr lang="pl-PL" dirty="0" err="1"/>
              <a:t>AgNPs</a:t>
            </a:r>
            <a:endParaRPr lang="pl-PL" dirty="0"/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25F6A7DC-E04A-43CA-9ABA-67FDE8D42357}"/>
              </a:ext>
            </a:extLst>
          </p:cNvPr>
          <p:cNvSpPr txBox="1"/>
          <p:nvPr/>
        </p:nvSpPr>
        <p:spPr>
          <a:xfrm>
            <a:off x="4631260" y="278290"/>
            <a:ext cx="5476695" cy="347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/2MIC                              MIC                                    2xMIC</a:t>
            </a:r>
          </a:p>
        </p:txBody>
      </p:sp>
      <p:sp>
        <p:nvSpPr>
          <p:cNvPr id="119" name="pole tekstowe 118">
            <a:extLst>
              <a:ext uri="{FF2B5EF4-FFF2-40B4-BE49-F238E27FC236}">
                <a16:creationId xmlns:a16="http://schemas.microsoft.com/office/drawing/2014/main" id="{642C76EB-BA0C-4D0C-A48F-C63E185B30CB}"/>
              </a:ext>
            </a:extLst>
          </p:cNvPr>
          <p:cNvSpPr txBox="1"/>
          <p:nvPr/>
        </p:nvSpPr>
        <p:spPr>
          <a:xfrm>
            <a:off x="334337" y="7006558"/>
            <a:ext cx="103574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microbial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vity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llulan-based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nocomposites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pl-PL" sz="1600">
                <a:latin typeface="Times New Roman" panose="02020603050405020304" pitchFamily="18" charset="0"/>
                <a:cs typeface="Times New Roman" panose="02020603050405020304" pitchFamily="18" charset="0"/>
              </a:rPr>
              <a:t>AgNPs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cteria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3;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etitions</a:t>
            </a:r>
            <a:r>
              <a:rPr lang="pl-PL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;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pl-PL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pole tekstowe 3">
            <a:extLst>
              <a:ext uri="{FF2B5EF4-FFF2-40B4-BE49-F238E27FC236}">
                <a16:creationId xmlns:a16="http://schemas.microsoft.com/office/drawing/2014/main" id="{79DC67A2-C075-44FD-A16F-0E8BF00B80BD}"/>
              </a:ext>
            </a:extLst>
          </p:cNvPr>
          <p:cNvSpPr txBox="1"/>
          <p:nvPr/>
        </p:nvSpPr>
        <p:spPr>
          <a:xfrm>
            <a:off x="4480481" y="921381"/>
            <a:ext cx="301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</a:t>
            </a:r>
          </a:p>
        </p:txBody>
      </p:sp>
      <p:sp>
        <p:nvSpPr>
          <p:cNvPr id="20" name="pole tekstowe 19">
            <a:extLst>
              <a:ext uri="{FF2B5EF4-FFF2-40B4-BE49-F238E27FC236}">
                <a16:creationId xmlns:a16="http://schemas.microsoft.com/office/drawing/2014/main" id="{5C729FD0-3A8E-48A6-B05E-AB71F4F86500}"/>
              </a:ext>
            </a:extLst>
          </p:cNvPr>
          <p:cNvSpPr txBox="1"/>
          <p:nvPr/>
        </p:nvSpPr>
        <p:spPr>
          <a:xfrm>
            <a:off x="5195813" y="1989068"/>
            <a:ext cx="30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3</a:t>
            </a:r>
          </a:p>
        </p:txBody>
      </p:sp>
      <p:sp>
        <p:nvSpPr>
          <p:cNvPr id="21" name="pole tekstowe 20">
            <a:extLst>
              <a:ext uri="{FF2B5EF4-FFF2-40B4-BE49-F238E27FC236}">
                <a16:creationId xmlns:a16="http://schemas.microsoft.com/office/drawing/2014/main" id="{A79E75F3-EF44-41D2-A530-CD25F1C2A41A}"/>
              </a:ext>
            </a:extLst>
          </p:cNvPr>
          <p:cNvSpPr txBox="1"/>
          <p:nvPr/>
        </p:nvSpPr>
        <p:spPr>
          <a:xfrm>
            <a:off x="5129076" y="910201"/>
            <a:ext cx="301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</a:t>
            </a:r>
          </a:p>
        </p:txBody>
      </p:sp>
      <p:sp>
        <p:nvSpPr>
          <p:cNvPr id="22" name="pole tekstowe 21">
            <a:extLst>
              <a:ext uri="{FF2B5EF4-FFF2-40B4-BE49-F238E27FC236}">
                <a16:creationId xmlns:a16="http://schemas.microsoft.com/office/drawing/2014/main" id="{97C22756-3137-4743-9319-4028D57F8468}"/>
              </a:ext>
            </a:extLst>
          </p:cNvPr>
          <p:cNvSpPr txBox="1"/>
          <p:nvPr/>
        </p:nvSpPr>
        <p:spPr>
          <a:xfrm>
            <a:off x="4559791" y="1989068"/>
            <a:ext cx="3001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C</a:t>
            </a:r>
          </a:p>
        </p:txBody>
      </p:sp>
      <p:pic>
        <p:nvPicPr>
          <p:cNvPr id="23" name="Obraz 22">
            <a:extLst>
              <a:ext uri="{FF2B5EF4-FFF2-40B4-BE49-F238E27FC236}">
                <a16:creationId xmlns:a16="http://schemas.microsoft.com/office/drawing/2014/main" id="{829963B3-FEFD-4009-A247-28AC747B25A5}"/>
              </a:ext>
            </a:extLst>
          </p:cNvPr>
          <p:cNvPicPr/>
          <p:nvPr/>
        </p:nvPicPr>
        <p:blipFill rotWithShape="1">
          <a:blip r:embed="rId2"/>
          <a:srcRect l="43670" t="27938" r="36471" b="35795"/>
          <a:stretch/>
        </p:blipFill>
        <p:spPr bwMode="auto">
          <a:xfrm rot="10800000">
            <a:off x="3984273" y="652273"/>
            <a:ext cx="2091863" cy="208129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4" name="Obraz 23" descr="C:\folie_3% pullulan +0,75% glicerol\listopad zdjęcia oddziaływania\IMG_20221020_102858.jpg">
            <a:extLst>
              <a:ext uri="{FF2B5EF4-FFF2-40B4-BE49-F238E27FC236}">
                <a16:creationId xmlns:a16="http://schemas.microsoft.com/office/drawing/2014/main" id="{5ED701EB-6797-4C00-AC54-C0FD0D6855E6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01" r="6144" b="10696"/>
          <a:stretch/>
        </p:blipFill>
        <p:spPr bwMode="auto">
          <a:xfrm>
            <a:off x="6076143" y="652412"/>
            <a:ext cx="2091862" cy="208454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pole tekstowe 5">
            <a:extLst>
              <a:ext uri="{FF2B5EF4-FFF2-40B4-BE49-F238E27FC236}">
                <a16:creationId xmlns:a16="http://schemas.microsoft.com/office/drawing/2014/main" id="{04AF76EE-55AB-4AF1-B9B9-CA4D421597F4}"/>
              </a:ext>
            </a:extLst>
          </p:cNvPr>
          <p:cNvSpPr txBox="1"/>
          <p:nvPr/>
        </p:nvSpPr>
        <p:spPr>
          <a:xfrm>
            <a:off x="4455269" y="904887"/>
            <a:ext cx="199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</a:t>
            </a:r>
          </a:p>
        </p:txBody>
      </p:sp>
      <p:sp>
        <p:nvSpPr>
          <p:cNvPr id="27" name="pole tekstowe 26">
            <a:extLst>
              <a:ext uri="{FF2B5EF4-FFF2-40B4-BE49-F238E27FC236}">
                <a16:creationId xmlns:a16="http://schemas.microsoft.com/office/drawing/2014/main" id="{F3782C29-045C-4BD9-BA27-EF0ACBD8DFD9}"/>
              </a:ext>
            </a:extLst>
          </p:cNvPr>
          <p:cNvSpPr txBox="1"/>
          <p:nvPr/>
        </p:nvSpPr>
        <p:spPr>
          <a:xfrm>
            <a:off x="5133340" y="911895"/>
            <a:ext cx="199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</a:t>
            </a:r>
          </a:p>
        </p:txBody>
      </p:sp>
      <p:sp>
        <p:nvSpPr>
          <p:cNvPr id="28" name="pole tekstowe 27">
            <a:extLst>
              <a:ext uri="{FF2B5EF4-FFF2-40B4-BE49-F238E27FC236}">
                <a16:creationId xmlns:a16="http://schemas.microsoft.com/office/drawing/2014/main" id="{2478F645-7235-4B4D-A97E-878350F3DB6B}"/>
              </a:ext>
            </a:extLst>
          </p:cNvPr>
          <p:cNvSpPr txBox="1"/>
          <p:nvPr/>
        </p:nvSpPr>
        <p:spPr>
          <a:xfrm>
            <a:off x="5195800" y="1958862"/>
            <a:ext cx="199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3</a:t>
            </a:r>
          </a:p>
        </p:txBody>
      </p:sp>
      <p:sp>
        <p:nvSpPr>
          <p:cNvPr id="29" name="pole tekstowe 28">
            <a:extLst>
              <a:ext uri="{FF2B5EF4-FFF2-40B4-BE49-F238E27FC236}">
                <a16:creationId xmlns:a16="http://schemas.microsoft.com/office/drawing/2014/main" id="{2834E8A4-6513-418D-BAE5-438AFFF06BAB}"/>
              </a:ext>
            </a:extLst>
          </p:cNvPr>
          <p:cNvSpPr txBox="1"/>
          <p:nvPr/>
        </p:nvSpPr>
        <p:spPr>
          <a:xfrm>
            <a:off x="4555098" y="1958862"/>
            <a:ext cx="1996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C</a:t>
            </a:r>
          </a:p>
        </p:txBody>
      </p:sp>
      <p:grpSp>
        <p:nvGrpSpPr>
          <p:cNvPr id="7" name="Grupa 6">
            <a:extLst>
              <a:ext uri="{FF2B5EF4-FFF2-40B4-BE49-F238E27FC236}">
                <a16:creationId xmlns:a16="http://schemas.microsoft.com/office/drawing/2014/main" id="{F57AB6F3-7C46-4E44-9F2B-8E04D5D19E3E}"/>
              </a:ext>
            </a:extLst>
          </p:cNvPr>
          <p:cNvGrpSpPr/>
          <p:nvPr/>
        </p:nvGrpSpPr>
        <p:grpSpPr>
          <a:xfrm>
            <a:off x="3984267" y="639731"/>
            <a:ext cx="6369490" cy="6352550"/>
            <a:chOff x="3984267" y="639731"/>
            <a:chExt cx="6369490" cy="6352550"/>
          </a:xfrm>
        </p:grpSpPr>
        <p:grpSp>
          <p:nvGrpSpPr>
            <p:cNvPr id="30" name="Grupa 29">
              <a:extLst>
                <a:ext uri="{FF2B5EF4-FFF2-40B4-BE49-F238E27FC236}">
                  <a16:creationId xmlns:a16="http://schemas.microsoft.com/office/drawing/2014/main" id="{FF07A71C-835C-4A30-8B26-82EDDA881908}"/>
                </a:ext>
              </a:extLst>
            </p:cNvPr>
            <p:cNvGrpSpPr/>
            <p:nvPr/>
          </p:nvGrpSpPr>
          <p:grpSpPr>
            <a:xfrm>
              <a:off x="3984273" y="639731"/>
              <a:ext cx="6369484" cy="6352550"/>
              <a:chOff x="3984279" y="637514"/>
              <a:chExt cx="6369484" cy="6352550"/>
            </a:xfrm>
          </p:grpSpPr>
          <p:pic>
            <p:nvPicPr>
              <p:cNvPr id="31" name="Obraz 30">
                <a:extLst>
                  <a:ext uri="{FF2B5EF4-FFF2-40B4-BE49-F238E27FC236}">
                    <a16:creationId xmlns:a16="http://schemas.microsoft.com/office/drawing/2014/main" id="{4B0DF349-3165-4D62-9BDE-318FF5F64EC7}"/>
                  </a:ext>
                </a:extLst>
              </p:cNvPr>
              <p:cNvPicPr/>
              <p:nvPr/>
            </p:nvPicPr>
            <p:blipFill rotWithShape="1">
              <a:blip r:embed="rId2"/>
              <a:srcRect l="43670" t="27938" r="36471" b="35795"/>
              <a:stretch/>
            </p:blipFill>
            <p:spPr bwMode="auto">
              <a:xfrm rot="10800000">
                <a:off x="3984279" y="655661"/>
                <a:ext cx="2091863" cy="2081296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2" name="Obraz 31" descr="C:\folie_3% pullulan +0,75% glicerol\listopad zdjęcia oddziaływania\IMG_20221020_102858.jpg">
                <a:extLst>
                  <a:ext uri="{FF2B5EF4-FFF2-40B4-BE49-F238E27FC236}">
                    <a16:creationId xmlns:a16="http://schemas.microsoft.com/office/drawing/2014/main" id="{FD801BF3-3A9A-41E1-A37F-A09398DDD817}"/>
                  </a:ext>
                </a:extLst>
              </p:cNvPr>
              <p:cNvPicPr/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001" r="6144" b="10696"/>
              <a:stretch/>
            </p:blipFill>
            <p:spPr bwMode="auto">
              <a:xfrm>
                <a:off x="6076149" y="655800"/>
                <a:ext cx="2091862" cy="2084546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3" name="Obraz 32" descr="C:\folie_3% pullulan +0,75% glicerol\metoda patyczkiem\IMG_20220527_122905.jpg">
                <a:extLst>
                  <a:ext uri="{FF2B5EF4-FFF2-40B4-BE49-F238E27FC236}">
                    <a16:creationId xmlns:a16="http://schemas.microsoft.com/office/drawing/2014/main" id="{3EBBCE7A-84BB-47E9-9AA6-F0EA550587E6}"/>
                  </a:ext>
                </a:extLst>
              </p:cNvPr>
              <p:cNvPicPr/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6547" b="7948"/>
              <a:stretch/>
            </p:blipFill>
            <p:spPr bwMode="auto">
              <a:xfrm>
                <a:off x="8168012" y="637514"/>
                <a:ext cx="2185744" cy="2111840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4" name="Obraz 33" descr="C:\folie_3% pullulan +0,75% glicerol\listopad zdjęcia oddziaływania\IMG_20221020_102640.jpg">
                <a:extLst>
                  <a:ext uri="{FF2B5EF4-FFF2-40B4-BE49-F238E27FC236}">
                    <a16:creationId xmlns:a16="http://schemas.microsoft.com/office/drawing/2014/main" id="{B5A065B7-FD1E-4AD1-A420-59C1BC364DBF}"/>
                  </a:ext>
                </a:extLst>
              </p:cNvPr>
              <p:cNvPicPr/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699" r="7143" b="5730"/>
              <a:stretch/>
            </p:blipFill>
            <p:spPr bwMode="auto">
              <a:xfrm>
                <a:off x="3984295" y="2736958"/>
                <a:ext cx="2091862" cy="2135371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5" name="Obraz 34" descr="C:\folie_3% pullulan +0,75% glicerol\listopad zdjęcia oddziaływania\IMG_20221020_102757.jpg">
                <a:extLst>
                  <a:ext uri="{FF2B5EF4-FFF2-40B4-BE49-F238E27FC236}">
                    <a16:creationId xmlns:a16="http://schemas.microsoft.com/office/drawing/2014/main" id="{942F15CD-89A8-4984-9AF9-08A7F201E466}"/>
                  </a:ext>
                </a:extLst>
              </p:cNvPr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325" r="8008" b="11163"/>
              <a:stretch/>
            </p:blipFill>
            <p:spPr bwMode="auto">
              <a:xfrm>
                <a:off x="6019149" y="2746103"/>
                <a:ext cx="2185744" cy="2111189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6" name="Obraz 35" descr="C:\Users\AcerAspire\Desktop\IS 2XMIC.png">
                <a:extLst>
                  <a:ext uri="{FF2B5EF4-FFF2-40B4-BE49-F238E27FC236}">
                    <a16:creationId xmlns:a16="http://schemas.microsoft.com/office/drawing/2014/main" id="{891D1329-D80B-4104-9DDA-61D6409F9B01}"/>
                  </a:ext>
                </a:extLst>
              </p:cNvPr>
              <p:cNvPicPr/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56" t="15894" b="13907"/>
              <a:stretch/>
            </p:blipFill>
            <p:spPr bwMode="auto">
              <a:xfrm>
                <a:off x="8168019" y="2742853"/>
                <a:ext cx="2185744" cy="2111189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7" name="Obraz 36" descr="C:\folie_3% pullulan +0,75% glicerol\metoda patyczkiem\Nowy folder\IMG_20220719_132722.jpg">
                <a:extLst>
                  <a:ext uri="{FF2B5EF4-FFF2-40B4-BE49-F238E27FC236}">
                    <a16:creationId xmlns:a16="http://schemas.microsoft.com/office/drawing/2014/main" id="{70B86FC1-2A70-4B6D-B99E-9EFB94E0E4CA}"/>
                  </a:ext>
                </a:extLst>
              </p:cNvPr>
              <p:cNvPicPr/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71" t="27136" r="13203" b="13910"/>
              <a:stretch/>
            </p:blipFill>
            <p:spPr bwMode="auto">
              <a:xfrm>
                <a:off x="3984286" y="4872331"/>
                <a:ext cx="2034857" cy="2117733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8" name="Obraz 37" descr="C:\folie_3% pullulan +0,75% glicerol\listopad zdjęcia oddziaływania\IMG_20221020_102616.jpg">
                <a:extLst>
                  <a:ext uri="{FF2B5EF4-FFF2-40B4-BE49-F238E27FC236}">
                    <a16:creationId xmlns:a16="http://schemas.microsoft.com/office/drawing/2014/main" id="{4948D96F-2971-478F-A65A-90AA1D686294}"/>
                  </a:ext>
                </a:extLst>
              </p:cNvPr>
              <p:cNvPicPr/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3009" r="11905" b="9324"/>
              <a:stretch/>
            </p:blipFill>
            <p:spPr bwMode="auto">
              <a:xfrm>
                <a:off x="6019149" y="4854693"/>
                <a:ext cx="2148856" cy="2135371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39" name="Obraz 38" descr="C:\folie_3% pullulan +0,75% glicerol\listopad zdjęcia oddziaływania\IMG_20221020_102825.jpg">
                <a:extLst>
                  <a:ext uri="{FF2B5EF4-FFF2-40B4-BE49-F238E27FC236}">
                    <a16:creationId xmlns:a16="http://schemas.microsoft.com/office/drawing/2014/main" id="{D5EDDC2D-9CB5-452C-AA11-6C7703642F7C}"/>
                  </a:ext>
                </a:extLst>
              </p:cNvPr>
              <p:cNvPicPr/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111" t="25723" r="11111" b="15815"/>
              <a:stretch/>
            </p:blipFill>
            <p:spPr bwMode="auto">
              <a:xfrm>
                <a:off x="8168012" y="4854693"/>
                <a:ext cx="2185744" cy="2135371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pic>
          <p:nvPicPr>
            <p:cNvPr id="40" name="Obraz 39">
              <a:extLst>
                <a:ext uri="{FF2B5EF4-FFF2-40B4-BE49-F238E27FC236}">
                  <a16:creationId xmlns:a16="http://schemas.microsoft.com/office/drawing/2014/main" id="{2A55CC0E-A7AA-4C4C-B2FC-97ACCD2B6FB6}"/>
                </a:ext>
              </a:extLst>
            </p:cNvPr>
            <p:cNvPicPr/>
            <p:nvPr/>
          </p:nvPicPr>
          <p:blipFill rotWithShape="1">
            <a:blip r:embed="rId2"/>
            <a:srcRect l="43670" t="27938" r="36471" b="35795"/>
            <a:stretch/>
          </p:blipFill>
          <p:spPr bwMode="auto">
            <a:xfrm rot="10800000">
              <a:off x="3984267" y="654490"/>
              <a:ext cx="2091863" cy="2081296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1" name="Obraz 40" descr="C:\folie_3% pullulan +0,75% glicerol\listopad zdjęcia oddziaływania\IMG_20221020_102858.jpg">
              <a:extLst>
                <a:ext uri="{FF2B5EF4-FFF2-40B4-BE49-F238E27FC236}">
                  <a16:creationId xmlns:a16="http://schemas.microsoft.com/office/drawing/2014/main" id="{6165FF68-E09F-48D9-9995-29163FFB10E5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001" r="6144" b="10696"/>
            <a:stretch/>
          </p:blipFill>
          <p:spPr bwMode="auto">
            <a:xfrm>
              <a:off x="6076137" y="654629"/>
              <a:ext cx="2091862" cy="2084546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42" name="pole tekstowe 41">
              <a:extLst>
                <a:ext uri="{FF2B5EF4-FFF2-40B4-BE49-F238E27FC236}">
                  <a16:creationId xmlns:a16="http://schemas.microsoft.com/office/drawing/2014/main" id="{EB967CB5-C81C-4F40-9E3D-22803E7EE003}"/>
                </a:ext>
              </a:extLst>
            </p:cNvPr>
            <p:cNvSpPr txBox="1"/>
            <p:nvPr/>
          </p:nvSpPr>
          <p:spPr>
            <a:xfrm>
              <a:off x="4455263" y="907104"/>
              <a:ext cx="1996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1</a:t>
              </a:r>
            </a:p>
          </p:txBody>
        </p:sp>
        <p:sp>
          <p:nvSpPr>
            <p:cNvPr id="43" name="pole tekstowe 42">
              <a:extLst>
                <a:ext uri="{FF2B5EF4-FFF2-40B4-BE49-F238E27FC236}">
                  <a16:creationId xmlns:a16="http://schemas.microsoft.com/office/drawing/2014/main" id="{51A1AEE5-D209-460A-8173-81336EF94FD5}"/>
                </a:ext>
              </a:extLst>
            </p:cNvPr>
            <p:cNvSpPr txBox="1"/>
            <p:nvPr/>
          </p:nvSpPr>
          <p:spPr>
            <a:xfrm>
              <a:off x="5133334" y="914112"/>
              <a:ext cx="1996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2</a:t>
              </a:r>
            </a:p>
          </p:txBody>
        </p:sp>
        <p:sp>
          <p:nvSpPr>
            <p:cNvPr id="44" name="pole tekstowe 43">
              <a:extLst>
                <a:ext uri="{FF2B5EF4-FFF2-40B4-BE49-F238E27FC236}">
                  <a16:creationId xmlns:a16="http://schemas.microsoft.com/office/drawing/2014/main" id="{D1B8B65B-7EEB-45D7-9A75-B1A90EDA3AB5}"/>
                </a:ext>
              </a:extLst>
            </p:cNvPr>
            <p:cNvSpPr txBox="1"/>
            <p:nvPr/>
          </p:nvSpPr>
          <p:spPr>
            <a:xfrm>
              <a:off x="5195794" y="1961079"/>
              <a:ext cx="1996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3</a:t>
              </a:r>
            </a:p>
          </p:txBody>
        </p:sp>
        <p:sp>
          <p:nvSpPr>
            <p:cNvPr id="45" name="pole tekstowe 44">
              <a:extLst>
                <a:ext uri="{FF2B5EF4-FFF2-40B4-BE49-F238E27FC236}">
                  <a16:creationId xmlns:a16="http://schemas.microsoft.com/office/drawing/2014/main" id="{363808BC-385B-47D7-903E-0FC544BF616D}"/>
                </a:ext>
              </a:extLst>
            </p:cNvPr>
            <p:cNvSpPr txBox="1"/>
            <p:nvPr/>
          </p:nvSpPr>
          <p:spPr>
            <a:xfrm>
              <a:off x="4555092" y="1961079"/>
              <a:ext cx="1996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9670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8C6AA0FD-D045-43D9-A6FC-E36360F924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9733132"/>
              </p:ext>
            </p:extLst>
          </p:nvPr>
        </p:nvGraphicFramePr>
        <p:xfrm>
          <a:off x="797668" y="457309"/>
          <a:ext cx="2537128" cy="691625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37128">
                  <a:extLst>
                    <a:ext uri="{9D8B030D-6E8A-4147-A177-3AD203B41FA5}">
                      <a16:colId xmlns:a16="http://schemas.microsoft.com/office/drawing/2014/main" val="3789433340"/>
                    </a:ext>
                  </a:extLst>
                </a:gridCol>
              </a:tblGrid>
              <a:tr h="1175453">
                <a:tc>
                  <a:txBody>
                    <a:bodyPr/>
                    <a:lstStyle/>
                    <a:p>
                      <a:pPr algn="l"/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6712336"/>
                  </a:ext>
                </a:extLst>
              </a:tr>
              <a:tr h="752791">
                <a:tc>
                  <a:txBody>
                    <a:bodyPr/>
                    <a:lstStyle/>
                    <a:p>
                      <a:pPr algn="l"/>
                      <a:r>
                        <a:rPr lang="pl-PL" sz="1600" b="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steria</a:t>
                      </a:r>
                      <a:r>
                        <a:rPr lang="pl-PL" sz="1600" b="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600" b="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ocytogenes</a:t>
                      </a:r>
                      <a:endParaRPr lang="pl-PL" sz="1600" b="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/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CM 2191</a:t>
                      </a:r>
                      <a:endParaRPr lang="pl-PL" sz="1600" b="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1432564"/>
                  </a:ext>
                </a:extLst>
              </a:tr>
              <a:tr h="752791">
                <a:tc>
                  <a:txBody>
                    <a:bodyPr/>
                    <a:lstStyle/>
                    <a:p>
                      <a:pPr algn="l"/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1111575"/>
                  </a:ext>
                </a:extLst>
              </a:tr>
              <a:tr h="579193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3487069"/>
                  </a:ext>
                </a:extLst>
              </a:tr>
              <a:tr h="752791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pl-PL" sz="1600" b="0" i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seudomonas</a:t>
                      </a:r>
                      <a:r>
                        <a:rPr lang="pl-PL" sz="1600" b="0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600" b="0" i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eruginosa</a:t>
                      </a:r>
                      <a:endParaRPr lang="pl-PL" sz="16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pl-PL" sz="1600" b="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C 10145</a:t>
                      </a: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603763"/>
                  </a:ext>
                </a:extLst>
              </a:tr>
              <a:tr h="1397654">
                <a:tc>
                  <a:txBody>
                    <a:bodyPr/>
                    <a:lstStyle/>
                    <a:p>
                      <a:pPr algn="l"/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422223"/>
                  </a:ext>
                </a:extLst>
              </a:tr>
              <a:tr h="752791">
                <a:tc>
                  <a:txBody>
                    <a:bodyPr/>
                    <a:lstStyle/>
                    <a:p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almonella </a:t>
                      </a:r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nterica</a:t>
                      </a:r>
                      <a:endParaRPr lang="pl-PL" sz="1600" b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CM 2565</a:t>
                      </a: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6538287"/>
                  </a:ext>
                </a:extLst>
              </a:tr>
              <a:tr h="752791">
                <a:tc>
                  <a:txBody>
                    <a:bodyPr/>
                    <a:lstStyle/>
                    <a:p>
                      <a:pPr algn="l"/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7508469"/>
                  </a:ext>
                </a:extLst>
              </a:tr>
            </a:tbl>
          </a:graphicData>
        </a:graphic>
      </p:graphicFrame>
      <p:pic>
        <p:nvPicPr>
          <p:cNvPr id="18" name="Obraz 17" descr="C:\Users\AcerAspire\Downloads\pa 32_preview_rev_1.jpeg">
            <a:extLst>
              <a:ext uri="{FF2B5EF4-FFF2-40B4-BE49-F238E27FC236}">
                <a16:creationId xmlns:a16="http://schemas.microsoft.com/office/drawing/2014/main" id="{0A17F27C-9AEA-46A0-A463-75EB5DED8EA8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97" t="11653" r="10241"/>
          <a:stretch/>
        </p:blipFill>
        <p:spPr bwMode="auto">
          <a:xfrm>
            <a:off x="6008171" y="2894049"/>
            <a:ext cx="2212206" cy="214130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3" name="Obraz 12" descr="C:\folie_3% pullulan +0,75% glicerol\listopad zdjęcia oddziaływania\IMG_20221021_092944.jpg">
            <a:extLst>
              <a:ext uri="{FF2B5EF4-FFF2-40B4-BE49-F238E27FC236}">
                <a16:creationId xmlns:a16="http://schemas.microsoft.com/office/drawing/2014/main" id="{AFE8EAD6-C140-4EC4-A9DD-649D4A9204B1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511" r="6765" b="2791"/>
          <a:stretch/>
        </p:blipFill>
        <p:spPr bwMode="auto">
          <a:xfrm rot="16200000">
            <a:off x="3825590" y="724011"/>
            <a:ext cx="2182582" cy="217004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4" name="Obraz 13" descr="C:\folie_3% pullulan +0,75% glicerol\listopad zdjęcia oddziaływania\IMG_20221021_093041.jpg">
            <a:extLst>
              <a:ext uri="{FF2B5EF4-FFF2-40B4-BE49-F238E27FC236}">
                <a16:creationId xmlns:a16="http://schemas.microsoft.com/office/drawing/2014/main" id="{CB89ADA8-CD49-41AE-9480-8E0A614B6A28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2" t="24186" r="8007" b="13023"/>
          <a:stretch/>
        </p:blipFill>
        <p:spPr bwMode="auto">
          <a:xfrm rot="10800000">
            <a:off x="5998452" y="713080"/>
            <a:ext cx="2182582" cy="218096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Obraz 16" descr="C:\folie_3% pullulan +0,75% glicerol\listopad zdjęcia oddziaływania\IMG_20221021_092904.jpg">
            <a:extLst>
              <a:ext uri="{FF2B5EF4-FFF2-40B4-BE49-F238E27FC236}">
                <a16:creationId xmlns:a16="http://schemas.microsoft.com/office/drawing/2014/main" id="{B6FAFE80-912B-44A4-B172-6CDF26978E8E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651" r="6144" b="6511"/>
          <a:stretch/>
        </p:blipFill>
        <p:spPr bwMode="auto">
          <a:xfrm rot="10800000">
            <a:off x="3825589" y="2894052"/>
            <a:ext cx="2182582" cy="20982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Obraz 19" descr="C:\Users\AcerAspire\Downloads\pa 32 gotowe.jpg">
            <a:extLst>
              <a:ext uri="{FF2B5EF4-FFF2-40B4-BE49-F238E27FC236}">
                <a16:creationId xmlns:a16="http://schemas.microsoft.com/office/drawing/2014/main" id="{A7228CB4-3560-4BCD-BD67-CD6BBED2F345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45" t="10620" r="10578"/>
          <a:stretch/>
        </p:blipFill>
        <p:spPr bwMode="auto">
          <a:xfrm rot="5400000">
            <a:off x="8237288" y="2889045"/>
            <a:ext cx="2141751" cy="217557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1" name="Obraz 20" descr="C:\Users\AcerAspire\Downloads\es tło_preview_rev_1.jpeg">
            <a:extLst>
              <a:ext uri="{FF2B5EF4-FFF2-40B4-BE49-F238E27FC236}">
                <a16:creationId xmlns:a16="http://schemas.microsoft.com/office/drawing/2014/main" id="{1347444D-53E2-455A-A787-C385F42F535F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5589" y="4994475"/>
            <a:ext cx="2182582" cy="2164178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Obraz 21" descr="C:\Users\AcerAspire\Downloads\es tło2_preview_rev_1.jpeg">
            <a:extLst>
              <a:ext uri="{FF2B5EF4-FFF2-40B4-BE49-F238E27FC236}">
                <a16:creationId xmlns:a16="http://schemas.microsoft.com/office/drawing/2014/main" id="{9F7F9309-E6D0-4E1D-A298-2225D4DE026F}"/>
              </a:ext>
            </a:extLst>
          </p:cNvPr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6041272" y="4952892"/>
            <a:ext cx="2166393" cy="2245136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Obraz 22" descr="C:\Users\AcerAspire\Downloads\es tło_preview_rev_1(1).jpeg">
            <a:extLst>
              <a:ext uri="{FF2B5EF4-FFF2-40B4-BE49-F238E27FC236}">
                <a16:creationId xmlns:a16="http://schemas.microsoft.com/office/drawing/2014/main" id="{748244F6-E349-4732-9AB0-435539E2BF7E}"/>
              </a:ext>
            </a:extLst>
          </p:cNvPr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8222800" y="5004991"/>
            <a:ext cx="2166391" cy="2166395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pole tekstowe 23">
            <a:extLst>
              <a:ext uri="{FF2B5EF4-FFF2-40B4-BE49-F238E27FC236}">
                <a16:creationId xmlns:a16="http://schemas.microsoft.com/office/drawing/2014/main" id="{3486D80B-CE90-4EF5-BC7B-0E79DB1C0780}"/>
              </a:ext>
            </a:extLst>
          </p:cNvPr>
          <p:cNvSpPr txBox="1"/>
          <p:nvPr/>
        </p:nvSpPr>
        <p:spPr>
          <a:xfrm flipH="1">
            <a:off x="5818311" y="60057"/>
            <a:ext cx="2657814" cy="35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/>
              <a:t>Concentration</a:t>
            </a:r>
            <a:r>
              <a:rPr lang="pl-PL" dirty="0"/>
              <a:t> of </a:t>
            </a:r>
            <a:r>
              <a:rPr lang="pl-PL" dirty="0" err="1"/>
              <a:t>AgNPs</a:t>
            </a:r>
            <a:endParaRPr lang="pl-PL" dirty="0"/>
          </a:p>
        </p:txBody>
      </p:sp>
      <p:sp>
        <p:nvSpPr>
          <p:cNvPr id="25" name="pole tekstowe 24">
            <a:extLst>
              <a:ext uri="{FF2B5EF4-FFF2-40B4-BE49-F238E27FC236}">
                <a16:creationId xmlns:a16="http://schemas.microsoft.com/office/drawing/2014/main" id="{ECF24C9F-AEAA-4CD7-AEDF-ACCB37567E86}"/>
              </a:ext>
            </a:extLst>
          </p:cNvPr>
          <p:cNvSpPr txBox="1"/>
          <p:nvPr/>
        </p:nvSpPr>
        <p:spPr>
          <a:xfrm>
            <a:off x="4500641" y="361155"/>
            <a:ext cx="5714211" cy="3532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/2MIC                              MIC                                    2xMIC</a:t>
            </a:r>
          </a:p>
        </p:txBody>
      </p:sp>
      <p:sp>
        <p:nvSpPr>
          <p:cNvPr id="26" name="pole tekstowe 25">
            <a:extLst>
              <a:ext uri="{FF2B5EF4-FFF2-40B4-BE49-F238E27FC236}">
                <a16:creationId xmlns:a16="http://schemas.microsoft.com/office/drawing/2014/main" id="{953A5A8B-E7D7-413F-A4AC-C4D5A7B13278}"/>
              </a:ext>
            </a:extLst>
          </p:cNvPr>
          <p:cNvSpPr txBox="1"/>
          <p:nvPr/>
        </p:nvSpPr>
        <p:spPr>
          <a:xfrm>
            <a:off x="331034" y="7092685"/>
            <a:ext cx="21661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pl-PL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endParaRPr lang="pl-PL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Obraz 15" descr="C:\folie_3% pullulan +0,75% glicerol\listopad zdjęcia oddziaływania\IMG_20221021_093010.jpg">
            <a:extLst>
              <a:ext uri="{FF2B5EF4-FFF2-40B4-BE49-F238E27FC236}">
                <a16:creationId xmlns:a16="http://schemas.microsoft.com/office/drawing/2014/main" id="{97FEE7C6-DC72-4A24-9D6C-79AB6C11629D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66" t="31164" r="21061" b="17674"/>
          <a:stretch/>
        </p:blipFill>
        <p:spPr bwMode="auto">
          <a:xfrm rot="16200000">
            <a:off x="8180147" y="704088"/>
            <a:ext cx="2224064" cy="224204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pole tekstowe 2">
            <a:extLst>
              <a:ext uri="{FF2B5EF4-FFF2-40B4-BE49-F238E27FC236}">
                <a16:creationId xmlns:a16="http://schemas.microsoft.com/office/drawing/2014/main" id="{83C65D1D-E991-4A37-A27D-4D15C3E5969E}"/>
              </a:ext>
            </a:extLst>
          </p:cNvPr>
          <p:cNvSpPr txBox="1"/>
          <p:nvPr/>
        </p:nvSpPr>
        <p:spPr>
          <a:xfrm>
            <a:off x="4456106" y="1015484"/>
            <a:ext cx="311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</a:t>
            </a:r>
          </a:p>
        </p:txBody>
      </p:sp>
      <p:sp>
        <p:nvSpPr>
          <p:cNvPr id="19" name="pole tekstowe 18">
            <a:extLst>
              <a:ext uri="{FF2B5EF4-FFF2-40B4-BE49-F238E27FC236}">
                <a16:creationId xmlns:a16="http://schemas.microsoft.com/office/drawing/2014/main" id="{A057BCB7-96A2-44BD-A7EC-1E8454764DCC}"/>
              </a:ext>
            </a:extLst>
          </p:cNvPr>
          <p:cNvSpPr txBox="1"/>
          <p:nvPr/>
        </p:nvSpPr>
        <p:spPr>
          <a:xfrm>
            <a:off x="4534626" y="2230272"/>
            <a:ext cx="311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C</a:t>
            </a:r>
          </a:p>
        </p:txBody>
      </p:sp>
      <p:sp>
        <p:nvSpPr>
          <p:cNvPr id="28" name="pole tekstowe 27">
            <a:extLst>
              <a:ext uri="{FF2B5EF4-FFF2-40B4-BE49-F238E27FC236}">
                <a16:creationId xmlns:a16="http://schemas.microsoft.com/office/drawing/2014/main" id="{68640442-913B-4BE5-81B5-64C080E72573}"/>
              </a:ext>
            </a:extLst>
          </p:cNvPr>
          <p:cNvSpPr txBox="1"/>
          <p:nvPr/>
        </p:nvSpPr>
        <p:spPr>
          <a:xfrm>
            <a:off x="5190356" y="2223622"/>
            <a:ext cx="311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3</a:t>
            </a:r>
          </a:p>
        </p:txBody>
      </p:sp>
      <p:sp>
        <p:nvSpPr>
          <p:cNvPr id="29" name="pole tekstowe 28">
            <a:extLst>
              <a:ext uri="{FF2B5EF4-FFF2-40B4-BE49-F238E27FC236}">
                <a16:creationId xmlns:a16="http://schemas.microsoft.com/office/drawing/2014/main" id="{3550E230-1CC9-4BB2-8A86-8B35F71C5865}"/>
              </a:ext>
            </a:extLst>
          </p:cNvPr>
          <p:cNvSpPr txBox="1"/>
          <p:nvPr/>
        </p:nvSpPr>
        <p:spPr>
          <a:xfrm>
            <a:off x="5113960" y="1008834"/>
            <a:ext cx="311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2</a:t>
            </a:r>
          </a:p>
        </p:txBody>
      </p:sp>
      <p:pic>
        <p:nvPicPr>
          <p:cNvPr id="30" name="Obraz 29" descr="C:\folie_3% pullulan +0,75% glicerol\listopad zdjęcia oddziaływania\IMG_20221021_092944.jpg">
            <a:extLst>
              <a:ext uri="{FF2B5EF4-FFF2-40B4-BE49-F238E27FC236}">
                <a16:creationId xmlns:a16="http://schemas.microsoft.com/office/drawing/2014/main" id="{E0FBD919-0863-49E0-8959-9A1BB2076393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511" r="6765" b="2791"/>
          <a:stretch/>
        </p:blipFill>
        <p:spPr bwMode="auto">
          <a:xfrm rot="16200000">
            <a:off x="3825590" y="724012"/>
            <a:ext cx="2182582" cy="217004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1" name="Obraz 30" descr="C:\folie_3% pullulan +0,75% glicerol\listopad zdjęcia oddziaływania\IMG_20221021_093041.jpg">
            <a:extLst>
              <a:ext uri="{FF2B5EF4-FFF2-40B4-BE49-F238E27FC236}">
                <a16:creationId xmlns:a16="http://schemas.microsoft.com/office/drawing/2014/main" id="{42816676-F41B-414F-8438-9A468B466DE1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2" t="24186" r="8007" b="13023"/>
          <a:stretch/>
        </p:blipFill>
        <p:spPr bwMode="auto">
          <a:xfrm rot="10800000">
            <a:off x="5998452" y="713081"/>
            <a:ext cx="2182582" cy="218096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2" name="Obraz 31" descr="C:\Users\AcerAspire\Downloads\pa 32 gotowe.jpg">
            <a:extLst>
              <a:ext uri="{FF2B5EF4-FFF2-40B4-BE49-F238E27FC236}">
                <a16:creationId xmlns:a16="http://schemas.microsoft.com/office/drawing/2014/main" id="{D27573DA-9C28-4E16-A527-F4CC1032FCC7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45" t="10620" r="10578"/>
          <a:stretch/>
        </p:blipFill>
        <p:spPr bwMode="auto">
          <a:xfrm rot="5400000">
            <a:off x="8237288" y="2889046"/>
            <a:ext cx="2141751" cy="217557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3" name="Obraz 32" descr="C:\folie_3% pullulan +0,75% glicerol\listopad zdjęcia oddziaływania\IMG_20221021_093010.jpg">
            <a:extLst>
              <a:ext uri="{FF2B5EF4-FFF2-40B4-BE49-F238E27FC236}">
                <a16:creationId xmlns:a16="http://schemas.microsoft.com/office/drawing/2014/main" id="{734DE978-D1A8-4F40-B681-CDC58A9764F9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66" t="31164" r="21061" b="17674"/>
          <a:stretch/>
        </p:blipFill>
        <p:spPr bwMode="auto">
          <a:xfrm rot="16200000">
            <a:off x="8180147" y="704089"/>
            <a:ext cx="2224064" cy="224204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4" name="Obraz 33" descr="C:\Users\AcerAspire\Downloads\pa 32_preview_rev_1.jpeg">
            <a:extLst>
              <a:ext uri="{FF2B5EF4-FFF2-40B4-BE49-F238E27FC236}">
                <a16:creationId xmlns:a16="http://schemas.microsoft.com/office/drawing/2014/main" id="{4F0B23AF-F9AE-4915-AEE9-FE00C4D83F06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97" t="11653" r="10241"/>
          <a:stretch/>
        </p:blipFill>
        <p:spPr bwMode="auto">
          <a:xfrm>
            <a:off x="6008171" y="2894050"/>
            <a:ext cx="2212206" cy="214130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5" name="Obraz 34" descr="C:\folie_3% pullulan +0,75% glicerol\listopad zdjęcia oddziaływania\IMG_20221021_092904.jpg">
            <a:extLst>
              <a:ext uri="{FF2B5EF4-FFF2-40B4-BE49-F238E27FC236}">
                <a16:creationId xmlns:a16="http://schemas.microsoft.com/office/drawing/2014/main" id="{07C289CE-995D-40B2-A77B-C54CC6322EEF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651" r="6144" b="6511"/>
          <a:stretch/>
        </p:blipFill>
        <p:spPr bwMode="auto">
          <a:xfrm rot="10800000">
            <a:off x="3825589" y="2894053"/>
            <a:ext cx="2182582" cy="20982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6" name="Obraz 35" descr="C:\Users\AcerAspire\Downloads\es tło_preview_rev_1.jpeg">
            <a:extLst>
              <a:ext uri="{FF2B5EF4-FFF2-40B4-BE49-F238E27FC236}">
                <a16:creationId xmlns:a16="http://schemas.microsoft.com/office/drawing/2014/main" id="{195448D5-F7FE-4133-BC73-30DB797A6968}"/>
              </a:ext>
            </a:extLst>
          </p:cNvPr>
          <p:cNvPicPr/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25589" y="4994476"/>
            <a:ext cx="2182582" cy="2164178"/>
          </a:xfrm>
          <a:prstGeom prst="rect">
            <a:avLst/>
          </a:prstGeom>
          <a:noFill/>
          <a:ln>
            <a:noFill/>
          </a:ln>
        </p:spPr>
      </p:pic>
      <p:pic>
        <p:nvPicPr>
          <p:cNvPr id="37" name="Obraz 36" descr="C:\Users\AcerAspire\Downloads\es tło2_preview_rev_1.jpeg">
            <a:extLst>
              <a:ext uri="{FF2B5EF4-FFF2-40B4-BE49-F238E27FC236}">
                <a16:creationId xmlns:a16="http://schemas.microsoft.com/office/drawing/2014/main" id="{1D802AB6-DCA2-49AF-8791-7DE4207F3545}"/>
              </a:ext>
            </a:extLst>
          </p:cNvPr>
          <p:cNvPicPr/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6041272" y="4952893"/>
            <a:ext cx="2166393" cy="2245136"/>
          </a:xfrm>
          <a:prstGeom prst="rect">
            <a:avLst/>
          </a:prstGeom>
          <a:noFill/>
          <a:ln>
            <a:noFill/>
          </a:ln>
        </p:spPr>
      </p:pic>
      <p:pic>
        <p:nvPicPr>
          <p:cNvPr id="38" name="Obraz 37" descr="C:\folie_3% pullulan +0,75% glicerol\listopad zdjęcia oddziaływania\IMG_20221021_092944.jpg">
            <a:extLst>
              <a:ext uri="{FF2B5EF4-FFF2-40B4-BE49-F238E27FC236}">
                <a16:creationId xmlns:a16="http://schemas.microsoft.com/office/drawing/2014/main" id="{8D3571A0-2961-46B9-AA63-29F5F0BF986F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511" r="6765" b="2791"/>
          <a:stretch/>
        </p:blipFill>
        <p:spPr bwMode="auto">
          <a:xfrm rot="16200000">
            <a:off x="3825590" y="724013"/>
            <a:ext cx="2182582" cy="217004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39" name="Obraz 38" descr="C:\folie_3% pullulan +0,75% glicerol\listopad zdjęcia oddziaływania\IMG_20221021_093041.jpg">
            <a:extLst>
              <a:ext uri="{FF2B5EF4-FFF2-40B4-BE49-F238E27FC236}">
                <a16:creationId xmlns:a16="http://schemas.microsoft.com/office/drawing/2014/main" id="{2E78B476-0EDD-4657-836F-758703C5DBF9}"/>
              </a:ext>
            </a:extLst>
          </p:cNvPr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02" t="24186" r="8007" b="13023"/>
          <a:stretch/>
        </p:blipFill>
        <p:spPr bwMode="auto">
          <a:xfrm rot="10800000">
            <a:off x="5998452" y="713082"/>
            <a:ext cx="2182582" cy="218096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0" name="Obraz 39" descr="C:\Users\AcerAspire\Downloads\pa 32 gotowe.jpg">
            <a:extLst>
              <a:ext uri="{FF2B5EF4-FFF2-40B4-BE49-F238E27FC236}">
                <a16:creationId xmlns:a16="http://schemas.microsoft.com/office/drawing/2014/main" id="{858B9BE5-BD1B-4D5D-BE67-C2142F19B28F}"/>
              </a:ext>
            </a:extLst>
          </p:cNvPr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45" t="10620" r="10578"/>
          <a:stretch/>
        </p:blipFill>
        <p:spPr bwMode="auto">
          <a:xfrm rot="5400000">
            <a:off x="8237288" y="2889047"/>
            <a:ext cx="2141751" cy="217557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1" name="Obraz 40" descr="C:\folie_3% pullulan +0,75% glicerol\listopad zdjęcia oddziaływania\IMG_20221021_093010.jpg">
            <a:extLst>
              <a:ext uri="{FF2B5EF4-FFF2-40B4-BE49-F238E27FC236}">
                <a16:creationId xmlns:a16="http://schemas.microsoft.com/office/drawing/2014/main" id="{C68355B6-34F0-4A0D-9B22-3F03E36FA026}"/>
              </a:ext>
            </a:extLst>
          </p:cNvPr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66" t="31164" r="21061" b="17674"/>
          <a:stretch/>
        </p:blipFill>
        <p:spPr bwMode="auto">
          <a:xfrm rot="16200000">
            <a:off x="8180147" y="704090"/>
            <a:ext cx="2224064" cy="224204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4" name="Grupa 3">
            <a:extLst>
              <a:ext uri="{FF2B5EF4-FFF2-40B4-BE49-F238E27FC236}">
                <a16:creationId xmlns:a16="http://schemas.microsoft.com/office/drawing/2014/main" id="{6C05DEDE-9CAA-4989-A177-8E06443C13ED}"/>
              </a:ext>
            </a:extLst>
          </p:cNvPr>
          <p:cNvGrpSpPr/>
          <p:nvPr/>
        </p:nvGrpSpPr>
        <p:grpSpPr>
          <a:xfrm>
            <a:off x="3825589" y="751991"/>
            <a:ext cx="6587612" cy="6458306"/>
            <a:chOff x="3825589" y="751991"/>
            <a:chExt cx="6587612" cy="6458306"/>
          </a:xfrm>
        </p:grpSpPr>
        <p:pic>
          <p:nvPicPr>
            <p:cNvPr id="42" name="Obraz 41" descr="C:\Users\AcerAspire\Downloads\es tło_preview_rev_1(1).jpeg">
              <a:extLst>
                <a:ext uri="{FF2B5EF4-FFF2-40B4-BE49-F238E27FC236}">
                  <a16:creationId xmlns:a16="http://schemas.microsoft.com/office/drawing/2014/main" id="{C61B7345-C6A9-4BA8-B096-C700340A589B}"/>
                </a:ext>
              </a:extLst>
            </p:cNvPr>
            <p:cNvPicPr/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8222800" y="5043902"/>
              <a:ext cx="2166391" cy="216639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3" name="Obraz 42" descr="C:\Users\AcerAspire\Downloads\pa 32_preview_rev_1.jpeg">
              <a:extLst>
                <a:ext uri="{FF2B5EF4-FFF2-40B4-BE49-F238E27FC236}">
                  <a16:creationId xmlns:a16="http://schemas.microsoft.com/office/drawing/2014/main" id="{3494C5D7-3B9C-4146-8B09-C91D31C98B39}"/>
                </a:ext>
              </a:extLst>
            </p:cNvPr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97" t="11653" r="10241"/>
            <a:stretch/>
          </p:blipFill>
          <p:spPr bwMode="auto">
            <a:xfrm>
              <a:off x="6008171" y="2932961"/>
              <a:ext cx="2212206" cy="2141306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4" name="Obraz 43" descr="C:\folie_3% pullulan +0,75% glicerol\listopad zdjęcia oddziaływania\IMG_20221021_092904.jpg">
              <a:extLst>
                <a:ext uri="{FF2B5EF4-FFF2-40B4-BE49-F238E27FC236}">
                  <a16:creationId xmlns:a16="http://schemas.microsoft.com/office/drawing/2014/main" id="{CA51F065-7C9C-43E0-91AD-7DA7590F3DC2}"/>
                </a:ext>
              </a:extLst>
            </p:cNvPr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651" r="6144" b="6511"/>
            <a:stretch/>
          </p:blipFill>
          <p:spPr bwMode="auto">
            <a:xfrm rot="10800000">
              <a:off x="3825589" y="2932964"/>
              <a:ext cx="2182582" cy="209820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5" name="Obraz 44" descr="C:\Users\AcerAspire\Downloads\es tło_preview_rev_1.jpeg">
              <a:extLst>
                <a:ext uri="{FF2B5EF4-FFF2-40B4-BE49-F238E27FC236}">
                  <a16:creationId xmlns:a16="http://schemas.microsoft.com/office/drawing/2014/main" id="{6BDB2B90-9508-4FFC-87B0-4D8060D60CA0}"/>
                </a:ext>
              </a:extLst>
            </p:cNvPr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5589" y="5033387"/>
              <a:ext cx="2182582" cy="216417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" name="Obraz 45" descr="C:\Users\AcerAspire\Downloads\es tło2_preview_rev_1.jpeg">
              <a:extLst>
                <a:ext uri="{FF2B5EF4-FFF2-40B4-BE49-F238E27FC236}">
                  <a16:creationId xmlns:a16="http://schemas.microsoft.com/office/drawing/2014/main" id="{29A28C56-19EA-4A23-A0AF-D31A1FA5430B}"/>
                </a:ext>
              </a:extLst>
            </p:cNvPr>
            <p:cNvPicPr/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6041272" y="4991804"/>
              <a:ext cx="2166393" cy="224513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" name="Obraz 46" descr="C:\folie_3% pullulan +0,75% glicerol\listopad zdjęcia oddziaływania\IMG_20221021_092944.jpg">
              <a:extLst>
                <a:ext uri="{FF2B5EF4-FFF2-40B4-BE49-F238E27FC236}">
                  <a16:creationId xmlns:a16="http://schemas.microsoft.com/office/drawing/2014/main" id="{E644FDC9-D7F0-4118-9D92-D87FE89B1CB4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511" r="6765" b="2791"/>
            <a:stretch/>
          </p:blipFill>
          <p:spPr bwMode="auto">
            <a:xfrm rot="16200000">
              <a:off x="3825590" y="762924"/>
              <a:ext cx="2182582" cy="217004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8" name="Obraz 47" descr="C:\folie_3% pullulan +0,75% glicerol\listopad zdjęcia oddziaływania\IMG_20221021_093041.jpg">
              <a:extLst>
                <a:ext uri="{FF2B5EF4-FFF2-40B4-BE49-F238E27FC236}">
                  <a16:creationId xmlns:a16="http://schemas.microsoft.com/office/drawing/2014/main" id="{0F6A8CDB-DFCA-48FE-9D85-A3810F650432}"/>
                </a:ext>
              </a:extLst>
            </p:cNvPr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02" t="24186" r="8007" b="13023"/>
            <a:stretch/>
          </p:blipFill>
          <p:spPr bwMode="auto">
            <a:xfrm rot="10800000">
              <a:off x="5998452" y="751993"/>
              <a:ext cx="2182582" cy="218096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9" name="Obraz 48" descr="C:\Users\AcerAspire\Downloads\pa 32 gotowe.jpg">
              <a:extLst>
                <a:ext uri="{FF2B5EF4-FFF2-40B4-BE49-F238E27FC236}">
                  <a16:creationId xmlns:a16="http://schemas.microsoft.com/office/drawing/2014/main" id="{C16EDD87-72D7-41E3-9956-3B930D431F40}"/>
                </a:ext>
              </a:extLst>
            </p:cNvPr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45" t="10620" r="10578"/>
            <a:stretch/>
          </p:blipFill>
          <p:spPr bwMode="auto">
            <a:xfrm rot="5400000">
              <a:off x="8237288" y="2927958"/>
              <a:ext cx="2141751" cy="2175572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50" name="Obraz 49" descr="C:\folie_3% pullulan +0,75% glicerol\listopad zdjęcia oddziaływania\IMG_20221021_093010.jpg">
              <a:extLst>
                <a:ext uri="{FF2B5EF4-FFF2-40B4-BE49-F238E27FC236}">
                  <a16:creationId xmlns:a16="http://schemas.microsoft.com/office/drawing/2014/main" id="{D8B3A2E7-ADFF-4538-ABE6-DDE54CFA8E8D}"/>
                </a:ext>
              </a:extLst>
            </p:cNvPr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66" t="31164" r="21061" b="17674"/>
            <a:stretch/>
          </p:blipFill>
          <p:spPr bwMode="auto">
            <a:xfrm rot="16200000">
              <a:off x="8180147" y="743001"/>
              <a:ext cx="2224064" cy="2242044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6737596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>
            <a:extLst>
              <a:ext uri="{FF2B5EF4-FFF2-40B4-BE49-F238E27FC236}">
                <a16:creationId xmlns:a16="http://schemas.microsoft.com/office/drawing/2014/main" id="{0B634992-5BE9-4367-B4CB-864F7B6F0BF7}"/>
              </a:ext>
            </a:extLst>
          </p:cNvPr>
          <p:cNvSpPr txBox="1"/>
          <p:nvPr/>
        </p:nvSpPr>
        <p:spPr>
          <a:xfrm flipH="1">
            <a:off x="5797685" y="0"/>
            <a:ext cx="2688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 err="1"/>
              <a:t>Concentration</a:t>
            </a:r>
            <a:r>
              <a:rPr lang="pl-PL" dirty="0"/>
              <a:t> of </a:t>
            </a:r>
            <a:r>
              <a:rPr lang="pl-PL" dirty="0" err="1"/>
              <a:t>AgNPs</a:t>
            </a:r>
            <a:endParaRPr lang="pl-PL" dirty="0"/>
          </a:p>
        </p:txBody>
      </p:sp>
      <p:sp>
        <p:nvSpPr>
          <p:cNvPr id="5" name="pole tekstowe 4">
            <a:extLst>
              <a:ext uri="{FF2B5EF4-FFF2-40B4-BE49-F238E27FC236}">
                <a16:creationId xmlns:a16="http://schemas.microsoft.com/office/drawing/2014/main" id="{121296BB-78E7-486D-BE91-C1649F64DF48}"/>
              </a:ext>
            </a:extLst>
          </p:cNvPr>
          <p:cNvSpPr txBox="1"/>
          <p:nvPr/>
        </p:nvSpPr>
        <p:spPr>
          <a:xfrm>
            <a:off x="4375055" y="314823"/>
            <a:ext cx="5779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dirty="0"/>
              <a:t>1/2MIC                              MIC                                    2xMIC</a:t>
            </a:r>
          </a:p>
        </p:txBody>
      </p:sp>
      <p:graphicFrame>
        <p:nvGraphicFramePr>
          <p:cNvPr id="16" name="Tabela 15">
            <a:extLst>
              <a:ext uri="{FF2B5EF4-FFF2-40B4-BE49-F238E27FC236}">
                <a16:creationId xmlns:a16="http://schemas.microsoft.com/office/drawing/2014/main" id="{4A7BE99B-A8CB-4AB6-B04E-7233085E07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4927151"/>
              </p:ext>
            </p:extLst>
          </p:nvPr>
        </p:nvGraphicFramePr>
        <p:xfrm>
          <a:off x="1056407" y="1633481"/>
          <a:ext cx="2540926" cy="48409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40926">
                  <a:extLst>
                    <a:ext uri="{9D8B030D-6E8A-4147-A177-3AD203B41FA5}">
                      <a16:colId xmlns:a16="http://schemas.microsoft.com/office/drawing/2014/main" val="3789433340"/>
                    </a:ext>
                  </a:extLst>
                </a:gridCol>
              </a:tblGrid>
              <a:tr h="1338251">
                <a:tc>
                  <a:txBody>
                    <a:bodyPr/>
                    <a:lstStyle/>
                    <a:p>
                      <a:pPr algn="l"/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almonella </a:t>
                      </a:r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fantis</a:t>
                      </a:r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600" b="0" i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S</a:t>
                      </a:r>
                      <a:endParaRPr lang="pl-PL" sz="1600" b="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6712336"/>
                  </a:ext>
                </a:extLst>
              </a:tr>
              <a:tr h="522456">
                <a:tc>
                  <a:txBody>
                    <a:bodyPr/>
                    <a:lstStyle/>
                    <a:p>
                      <a:pPr algn="l"/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1111575"/>
                  </a:ext>
                </a:extLst>
              </a:tr>
              <a:tr h="1894439">
                <a:tc>
                  <a:txBody>
                    <a:bodyPr/>
                    <a:lstStyle/>
                    <a:p>
                      <a:endParaRPr lang="pl-PL" sz="1600" b="0" i="1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taphylococcus</a:t>
                      </a:r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ureus</a:t>
                      </a:r>
                      <a:endParaRPr lang="pl-PL" sz="1600" b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 2592</a:t>
                      </a: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3487069"/>
                  </a:ext>
                </a:extLst>
              </a:tr>
              <a:tr h="1085850">
                <a:tc>
                  <a:txBody>
                    <a:bodyPr/>
                    <a:lstStyle/>
                    <a:p>
                      <a:endParaRPr lang="pl-PL" sz="1600" b="0" i="1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endParaRPr lang="pl-PL" sz="1600" b="0" i="1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taphylococcus</a:t>
                      </a:r>
                      <a:r>
                        <a:rPr lang="pl-PL" sz="1600" b="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l-PL" sz="1600" b="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ureus</a:t>
                      </a:r>
                      <a:endParaRPr lang="pl-PL" sz="1600" b="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r>
                        <a:rPr lang="pl-PL" sz="16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CC 6538</a:t>
                      </a:r>
                      <a:endParaRPr lang="pl-PL" sz="16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653" marR="64653" marT="32326" marB="3232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6538287"/>
                  </a:ext>
                </a:extLst>
              </a:tr>
            </a:tbl>
          </a:graphicData>
        </a:graphic>
      </p:graphicFrame>
      <p:sp>
        <p:nvSpPr>
          <p:cNvPr id="26" name="pole tekstowe 25">
            <a:extLst>
              <a:ext uri="{FF2B5EF4-FFF2-40B4-BE49-F238E27FC236}">
                <a16:creationId xmlns:a16="http://schemas.microsoft.com/office/drawing/2014/main" id="{FBA51C8F-F365-44D6-AC6E-ABBBAB5C2503}"/>
              </a:ext>
            </a:extLst>
          </p:cNvPr>
          <p:cNvSpPr txBox="1"/>
          <p:nvPr/>
        </p:nvSpPr>
        <p:spPr>
          <a:xfrm>
            <a:off x="223622" y="7079309"/>
            <a:ext cx="2190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pl-P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endParaRPr lang="pl-PL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a 1">
            <a:extLst>
              <a:ext uri="{FF2B5EF4-FFF2-40B4-BE49-F238E27FC236}">
                <a16:creationId xmlns:a16="http://schemas.microsoft.com/office/drawing/2014/main" id="{DE222D0C-AF20-425D-9FF2-DF05D326AE5F}"/>
              </a:ext>
            </a:extLst>
          </p:cNvPr>
          <p:cNvGrpSpPr/>
          <p:nvPr/>
        </p:nvGrpSpPr>
        <p:grpSpPr>
          <a:xfrm>
            <a:off x="3745728" y="691515"/>
            <a:ext cx="6370371" cy="6389709"/>
            <a:chOff x="3745728" y="691515"/>
            <a:chExt cx="6370371" cy="6389709"/>
          </a:xfrm>
        </p:grpSpPr>
        <p:pic>
          <p:nvPicPr>
            <p:cNvPr id="18" name="Obraz 17" descr="C:\folie_3% pullulan +0,75% glicerol\metoda patyczkiem\IMG_20220624_094555.jpg">
              <a:extLst>
                <a:ext uri="{FF2B5EF4-FFF2-40B4-BE49-F238E27FC236}">
                  <a16:creationId xmlns:a16="http://schemas.microsoft.com/office/drawing/2014/main" id="{B5452ED4-ADD0-4111-BDE1-9EFDD15322C4}"/>
                </a:ext>
              </a:extLst>
            </p:cNvPr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3" t="26549" r="7143" b="9346"/>
            <a:stretch/>
          </p:blipFill>
          <p:spPr bwMode="auto">
            <a:xfrm rot="5400000">
              <a:off x="5866805" y="690215"/>
              <a:ext cx="2152993" cy="215868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9" name="Obraz 18" descr="C:\folie_3% pullulan +0,75% glicerol\listopad zdjęcia oddziaływania\IMG_20221020_102815.jpg">
              <a:extLst>
                <a:ext uri="{FF2B5EF4-FFF2-40B4-BE49-F238E27FC236}">
                  <a16:creationId xmlns:a16="http://schemas.microsoft.com/office/drawing/2014/main" id="{A580E21A-BA3E-47E0-B7AE-CDACDBF44EDC}"/>
                </a:ext>
              </a:extLst>
            </p:cNvPr>
            <p:cNvPicPr/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086" r="11806" b="12698"/>
            <a:stretch/>
          </p:blipFill>
          <p:spPr bwMode="auto">
            <a:xfrm>
              <a:off x="7977312" y="691515"/>
              <a:ext cx="2138787" cy="2158689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0" name="Obraz 19" descr="C:\folie_3% pullulan +0,75% glicerol\listopad zdjęcia oddziaływania\IMG_20221020_102519.jpg">
              <a:extLst>
                <a:ext uri="{FF2B5EF4-FFF2-40B4-BE49-F238E27FC236}">
                  <a16:creationId xmlns:a16="http://schemas.microsoft.com/office/drawing/2014/main" id="{A6EAA60D-0804-4994-A7F8-EE6AEC43C636}"/>
                </a:ext>
              </a:extLst>
            </p:cNvPr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009" r="15476" b="15556"/>
            <a:stretch/>
          </p:blipFill>
          <p:spPr bwMode="auto">
            <a:xfrm>
              <a:off x="3750462" y="2854558"/>
              <a:ext cx="2146841" cy="211593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2" name="Obraz 21" descr="C:\folie_3% pullulan +0,75% glicerol\listopad zdjęcia oddziaływania\IMG_20221020_102508.jpg">
              <a:extLst>
                <a:ext uri="{FF2B5EF4-FFF2-40B4-BE49-F238E27FC236}">
                  <a16:creationId xmlns:a16="http://schemas.microsoft.com/office/drawing/2014/main" id="{98932882-EAC6-4A77-8CA1-A4CEE77ED1D1}"/>
                </a:ext>
              </a:extLst>
            </p:cNvPr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468" r="4762" b="13755"/>
            <a:stretch/>
          </p:blipFill>
          <p:spPr bwMode="auto">
            <a:xfrm>
              <a:off x="7869677" y="2854558"/>
              <a:ext cx="2242367" cy="211593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3" name="Obraz 22" descr="C:\folie_3% pullulan +0,75% glicerol\listopad zdjęcia oddziaływania\IMG_20221020_102558.jpg">
              <a:extLst>
                <a:ext uri="{FF2B5EF4-FFF2-40B4-BE49-F238E27FC236}">
                  <a16:creationId xmlns:a16="http://schemas.microsoft.com/office/drawing/2014/main" id="{D0F0AA4E-A15D-43D0-BA83-9ABC67EB39E0}"/>
                </a:ext>
              </a:extLst>
            </p:cNvPr>
            <p:cNvPicPr/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3" t="24779" r="9524" b="12006"/>
            <a:stretch/>
          </p:blipFill>
          <p:spPr bwMode="auto">
            <a:xfrm>
              <a:off x="3760190" y="4953078"/>
              <a:ext cx="2146841" cy="212623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4" name="Obraz 23" descr="C:\folie_3% pullulan +0,75% glicerol\listopad zdjęcia oddziaływania\IMG_20221021_092705.jpg">
              <a:extLst>
                <a:ext uri="{FF2B5EF4-FFF2-40B4-BE49-F238E27FC236}">
                  <a16:creationId xmlns:a16="http://schemas.microsoft.com/office/drawing/2014/main" id="{49CD9274-7196-4585-B58E-44316A643BDF}"/>
                </a:ext>
              </a:extLst>
            </p:cNvPr>
            <p:cNvPicPr/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1" t="21904" r="4899" b="9047"/>
            <a:stretch/>
          </p:blipFill>
          <p:spPr bwMode="auto">
            <a:xfrm rot="16200000">
              <a:off x="5905619" y="4982262"/>
              <a:ext cx="2071693" cy="212623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5" name="Obraz 24" descr="C:\folie_3% pullulan +0,75% glicerol\listopad zdjęcia oddziaływania\IMG_20221021_092640.jpg">
              <a:extLst>
                <a:ext uri="{FF2B5EF4-FFF2-40B4-BE49-F238E27FC236}">
                  <a16:creationId xmlns:a16="http://schemas.microsoft.com/office/drawing/2014/main" id="{5861E76C-1B33-4A71-865B-E9AE9C479284}"/>
                </a:ext>
              </a:extLst>
            </p:cNvPr>
            <p:cNvPicPr/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0" t="22773" b="9901"/>
            <a:stretch/>
          </p:blipFill>
          <p:spPr bwMode="auto">
            <a:xfrm rot="16200000">
              <a:off x="7948045" y="4927420"/>
              <a:ext cx="2181158" cy="212262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8" name="Obraz 27" descr="C:\folie_3% pullulan +0,75% glicerol\listopad zdjęcia oddziaływania\IMG_20221020_102210.jpg">
              <a:extLst>
                <a:ext uri="{FF2B5EF4-FFF2-40B4-BE49-F238E27FC236}">
                  <a16:creationId xmlns:a16="http://schemas.microsoft.com/office/drawing/2014/main" id="{E91C57F0-8409-4978-832E-3F56E3231B93}"/>
                </a:ext>
              </a:extLst>
            </p:cNvPr>
            <p:cNvPicPr/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239" b="3971"/>
            <a:stretch/>
          </p:blipFill>
          <p:spPr bwMode="auto">
            <a:xfrm>
              <a:off x="3745728" y="693883"/>
              <a:ext cx="2158689" cy="2152993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1" name="Obraz 20" descr="C:\folie_3% pullulan +0,75% glicerol\listopad zdjęcia oddziaływania\IMG_20221020_102718.jpg">
              <a:extLst>
                <a:ext uri="{FF2B5EF4-FFF2-40B4-BE49-F238E27FC236}">
                  <a16:creationId xmlns:a16="http://schemas.microsoft.com/office/drawing/2014/main" id="{A0CEF452-9D9E-4D12-8406-7838EF6E1A4D}"/>
                </a:ext>
              </a:extLst>
            </p:cNvPr>
            <p:cNvPicPr/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25" t="30088" r="20237" b="15600"/>
            <a:stretch/>
          </p:blipFill>
          <p:spPr bwMode="auto">
            <a:xfrm>
              <a:off x="5890032" y="2854557"/>
              <a:ext cx="2077768" cy="2158688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14405436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</TotalTime>
  <Words>225</Words>
  <Application>Microsoft Office PowerPoint</Application>
  <PresentationFormat>Niestandardowy</PresentationFormat>
  <Paragraphs>63</Paragraphs>
  <Slides>5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  <vt:lpstr>Prezentacja programu PowerPoint</vt:lpstr>
      <vt:lpstr>Prezentacja programu PowerPoint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Joanna Trzcinska</dc:creator>
  <cp:lastModifiedBy>golinska@o365.umk.pl</cp:lastModifiedBy>
  <cp:revision>24</cp:revision>
  <dcterms:created xsi:type="dcterms:W3CDTF">2023-07-13T10:08:42Z</dcterms:created>
  <dcterms:modified xsi:type="dcterms:W3CDTF">2023-07-17T17:14:16Z</dcterms:modified>
</cp:coreProperties>
</file>